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9"/>
  </p:notesMasterIdLst>
  <p:sldIdLst>
    <p:sldId id="338" r:id="rId2"/>
    <p:sldId id="380" r:id="rId3"/>
    <p:sldId id="382" r:id="rId4"/>
    <p:sldId id="383" r:id="rId5"/>
    <p:sldId id="384" r:id="rId6"/>
    <p:sldId id="385" r:id="rId7"/>
    <p:sldId id="387" r:id="rId8"/>
  </p:sldIdLst>
  <p:sldSz cx="9144000" cy="6858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57" userDrawn="1">
          <p15:clr>
            <a:srgbClr val="A4A3A4"/>
          </p15:clr>
        </p15:guide>
        <p15:guide id="3" orient="horz" pos="220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021" autoAdjust="0"/>
    <p:restoredTop sz="95501" autoAdjust="0"/>
  </p:normalViewPr>
  <p:slideViewPr>
    <p:cSldViewPr snapToGrid="0" showGuides="1">
      <p:cViewPr varScale="1">
        <p:scale>
          <a:sx n="112" d="100"/>
          <a:sy n="112" d="100"/>
        </p:scale>
        <p:origin x="1176" y="176"/>
      </p:cViewPr>
      <p:guideLst>
        <p:guide orient="horz" pos="2160"/>
        <p:guide pos="2857"/>
        <p:guide orient="horz" pos="22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65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688" y="0"/>
            <a:ext cx="304165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EAA0EA-F1EC-4DF9-A0BC-FED8AD09DF4E}" type="datetimeFigureOut">
              <a:rPr lang="en-US" smtClean="0"/>
              <a:t>9/12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6050" y="1163638"/>
            <a:ext cx="4187825" cy="3140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8338"/>
            <a:ext cx="5616575" cy="36639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200"/>
            <a:ext cx="304165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688" y="8839200"/>
            <a:ext cx="304165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8F3BF3-D29D-4DBF-BD66-8DC089F40D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5102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9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153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9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561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9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6059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9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5870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9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1745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9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469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9/12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272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9/12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218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9/12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493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9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876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A21F-9499-4602-A35E-B727B52383B6}" type="datetimeFigureOut">
              <a:rPr lang="en-US" smtClean="0"/>
              <a:t>9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721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0A21F-9499-4602-A35E-B727B52383B6}" type="datetimeFigureOut">
              <a:rPr lang="en-US" smtClean="0"/>
              <a:t>9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D39E2C-94DA-4AC7-AF47-6E2E73F4D3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659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"/><Relationship Id="rId2" Type="http://schemas.openxmlformats.org/officeDocument/2006/relationships/image" Target="../media/image2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0" y="0"/>
            <a:ext cx="41201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Figure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. Feng et al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" name="Rectangle 1"/>
          <p:cNvSpPr/>
          <p:nvPr/>
        </p:nvSpPr>
        <p:spPr>
          <a:xfrm>
            <a:off x="3319975" y="567645"/>
            <a:ext cx="2771336" cy="57183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135" y="513946"/>
            <a:ext cx="8366760" cy="55504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84140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E7C6EAE-E16F-45CF-AE2A-72A6ADA3A7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6908"/>
            <a:ext cx="9144000" cy="180733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76255CB-5AE3-46AF-820C-7CEB11BF37F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466153"/>
            <a:ext cx="9395063" cy="216934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FFD695B-F632-47E9-8AF3-EAF21016053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273492"/>
            <a:ext cx="9144000" cy="181271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1684B4A-DA75-41AD-8A6B-318B62DFA74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7496" y="4629774"/>
            <a:ext cx="9412773" cy="215163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393F17D-F708-490E-AB52-03487833AC13}"/>
              </a:ext>
            </a:extLst>
          </p:cNvPr>
          <p:cNvSpPr txBox="1"/>
          <p:nvPr/>
        </p:nvSpPr>
        <p:spPr>
          <a:xfrm>
            <a:off x="0" y="0"/>
            <a:ext cx="40986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2. Feng et al.</a:t>
            </a:r>
          </a:p>
        </p:txBody>
      </p:sp>
    </p:spTree>
    <p:extLst>
      <p:ext uri="{BB962C8B-B14F-4D97-AF65-F5344CB8AC3E}">
        <p14:creationId xmlns:p14="http://schemas.microsoft.com/office/powerpoint/2010/main" val="35217592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96964C1-1E82-402A-BB9B-FC331C6DD5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64892" y="1440054"/>
            <a:ext cx="9418320" cy="216724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76461C7-0241-4B2A-81CA-7D69C8FD69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57395" y="104371"/>
            <a:ext cx="9144000" cy="180744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8849C54-197D-4FDA-8D8C-AFA0B8AB0F6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157395" y="3197891"/>
            <a:ext cx="9144000" cy="181447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AD8FE71-2986-44BD-9B94-C67A993962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164890" y="4553177"/>
            <a:ext cx="9412773" cy="216048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FEEB301-0FC8-47D7-AB3A-7858C24263E0}"/>
              </a:ext>
            </a:extLst>
          </p:cNvPr>
          <p:cNvSpPr txBox="1"/>
          <p:nvPr/>
        </p:nvSpPr>
        <p:spPr>
          <a:xfrm>
            <a:off x="-1" y="0"/>
            <a:ext cx="49700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 Figure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2. Feng et al.-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continued</a:t>
            </a:r>
          </a:p>
        </p:txBody>
      </p:sp>
    </p:spTree>
    <p:extLst>
      <p:ext uri="{BB962C8B-B14F-4D97-AF65-F5344CB8AC3E}">
        <p14:creationId xmlns:p14="http://schemas.microsoft.com/office/powerpoint/2010/main" val="25847036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B6D61BE-9573-4831-9D32-75D454445B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405"/>
            <a:ext cx="9144000" cy="181447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70E2C86-D1C4-4A03-897D-36D3118F4F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7495" y="1359168"/>
            <a:ext cx="9412773" cy="217819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84292F2-2376-4FE8-85FA-4C1B8104828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29980" y="3166024"/>
            <a:ext cx="9144000" cy="181095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B57DC0B-C3F4-4192-93F8-3C05987B0DD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95" y="4523189"/>
            <a:ext cx="9372600" cy="215126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4C31337-3F0D-448B-BD9D-FD33B1E12C05}"/>
              </a:ext>
            </a:extLst>
          </p:cNvPr>
          <p:cNvSpPr txBox="1"/>
          <p:nvPr/>
        </p:nvSpPr>
        <p:spPr>
          <a:xfrm>
            <a:off x="-1" y="0"/>
            <a:ext cx="49700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 Figure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2. Feng et al.-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continued</a:t>
            </a:r>
          </a:p>
        </p:txBody>
      </p:sp>
    </p:spTree>
    <p:extLst>
      <p:ext uri="{BB962C8B-B14F-4D97-AF65-F5344CB8AC3E}">
        <p14:creationId xmlns:p14="http://schemas.microsoft.com/office/powerpoint/2010/main" val="29345469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622E878-7B17-4A43-B013-70845AD7AE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7686"/>
            <a:ext cx="9144000" cy="180569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497ECA8-7120-48CF-912E-9DFC24271C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7495" y="1525161"/>
            <a:ext cx="9412773" cy="216048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A9EEFE9-52B5-42F3-9C28-470193FE473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229808"/>
            <a:ext cx="9144000" cy="180744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6976711-C479-42E5-AE96-05CE8A4B4E8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7496" y="4545680"/>
            <a:ext cx="9436608" cy="216596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6D3FC94-C7D9-468B-B0F3-0A0773766E13}"/>
              </a:ext>
            </a:extLst>
          </p:cNvPr>
          <p:cNvSpPr txBox="1"/>
          <p:nvPr/>
        </p:nvSpPr>
        <p:spPr>
          <a:xfrm>
            <a:off x="-1" y="22485"/>
            <a:ext cx="49700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 Figure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2. Feng et al.-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continued</a:t>
            </a:r>
          </a:p>
        </p:txBody>
      </p:sp>
    </p:spTree>
    <p:extLst>
      <p:ext uri="{BB962C8B-B14F-4D97-AF65-F5344CB8AC3E}">
        <p14:creationId xmlns:p14="http://schemas.microsoft.com/office/powerpoint/2010/main" val="27578716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B93E6B1-D46B-452A-8F46-CEC23B730F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105" y="191619"/>
            <a:ext cx="2612199" cy="179745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800462C-3940-4805-A773-0224F58C31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108" y="1549948"/>
            <a:ext cx="2895557" cy="214278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65F8321-BC49-4FCE-BA50-B018E43106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51378" y="458235"/>
            <a:ext cx="1749704" cy="98154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33E9033-7354-4218-9BB9-11C1C1C9EACB}"/>
              </a:ext>
            </a:extLst>
          </p:cNvPr>
          <p:cNvSpPr txBox="1"/>
          <p:nvPr/>
        </p:nvSpPr>
        <p:spPr>
          <a:xfrm>
            <a:off x="-1" y="0"/>
            <a:ext cx="49700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 Figure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2. Feng et al.-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continued</a:t>
            </a:r>
          </a:p>
        </p:txBody>
      </p:sp>
    </p:spTree>
    <p:extLst>
      <p:ext uri="{BB962C8B-B14F-4D97-AF65-F5344CB8AC3E}">
        <p14:creationId xmlns:p14="http://schemas.microsoft.com/office/powerpoint/2010/main" val="22280469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5CFA77C-74B9-4181-BF60-092911BBF916}"/>
              </a:ext>
            </a:extLst>
          </p:cNvPr>
          <p:cNvSpPr txBox="1"/>
          <p:nvPr/>
        </p:nvSpPr>
        <p:spPr>
          <a:xfrm>
            <a:off x="0" y="0"/>
            <a:ext cx="22598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. Feng et al. </a:t>
            </a:r>
          </a:p>
        </p:txBody>
      </p:sp>
      <p:pic>
        <p:nvPicPr>
          <p:cNvPr id="4" name="Picture 3" descr="A close up of a logo&#10;&#10;Description automatically generated">
            <a:extLst>
              <a:ext uri="{FF2B5EF4-FFF2-40B4-BE49-F238E27FC236}">
                <a16:creationId xmlns:a16="http://schemas.microsoft.com/office/drawing/2014/main" id="{3F35467C-2519-44CC-8AE6-4E48E1BD85F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294"/>
          <a:stretch/>
        </p:blipFill>
        <p:spPr>
          <a:xfrm>
            <a:off x="93837" y="454336"/>
            <a:ext cx="8851392" cy="3102028"/>
          </a:xfrm>
          <a:prstGeom prst="rect">
            <a:avLst/>
          </a:prstGeom>
        </p:spPr>
      </p:pic>
      <p:pic>
        <p:nvPicPr>
          <p:cNvPr id="10" name="Picture 9" descr="A close up of a piece of paper&#10;&#10;Description automatically generated">
            <a:extLst>
              <a:ext uri="{FF2B5EF4-FFF2-40B4-BE49-F238E27FC236}">
                <a16:creationId xmlns:a16="http://schemas.microsoft.com/office/drawing/2014/main" id="{823F1A2E-81A9-434D-9BA5-8B3D9279688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28"/>
          <a:stretch/>
        </p:blipFill>
        <p:spPr>
          <a:xfrm>
            <a:off x="93837" y="3556364"/>
            <a:ext cx="8851392" cy="319321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B90D1F8-5AC2-CB49-84A3-32671F11723B}"/>
              </a:ext>
            </a:extLst>
          </p:cNvPr>
          <p:cNvSpPr txBox="1"/>
          <p:nvPr/>
        </p:nvSpPr>
        <p:spPr>
          <a:xfrm>
            <a:off x="3409408" y="3173969"/>
            <a:ext cx="2505814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Set No. in the primary scree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24CFD3B-CB86-974F-A392-7D325956BBDC}"/>
              </a:ext>
            </a:extLst>
          </p:cNvPr>
          <p:cNvSpPr txBox="1"/>
          <p:nvPr/>
        </p:nvSpPr>
        <p:spPr>
          <a:xfrm>
            <a:off x="3496492" y="6368663"/>
            <a:ext cx="272863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Set No. in the secondary scree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581AE3C-B37A-FE4A-BA41-58FA87A99E5A}"/>
              </a:ext>
            </a:extLst>
          </p:cNvPr>
          <p:cNvSpPr txBox="1"/>
          <p:nvPr/>
        </p:nvSpPr>
        <p:spPr>
          <a:xfrm>
            <a:off x="1618735" y="454336"/>
            <a:ext cx="147245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>
                <a:latin typeface="Arial Narrow" panose="020B0604020202020204" pitchFamily="34" charset="0"/>
                <a:cs typeface="Arial Narrow" panose="020B0604020202020204" pitchFamily="34" charset="0"/>
              </a:rPr>
              <a:t>Vaccine + alum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24072F0-F495-C247-B5B7-E82294D53B3C}"/>
              </a:ext>
            </a:extLst>
          </p:cNvPr>
          <p:cNvSpPr txBox="1"/>
          <p:nvPr/>
        </p:nvSpPr>
        <p:spPr>
          <a:xfrm>
            <a:off x="1523647" y="3600205"/>
            <a:ext cx="147245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>
                <a:latin typeface="Arial Narrow" panose="020B0604020202020204" pitchFamily="34" charset="0"/>
                <a:cs typeface="Arial Narrow" panose="020B0604020202020204" pitchFamily="34" charset="0"/>
              </a:rPr>
              <a:t>Vaccine + alum</a:t>
            </a:r>
          </a:p>
        </p:txBody>
      </p:sp>
    </p:spTree>
    <p:extLst>
      <p:ext uri="{BB962C8B-B14F-4D97-AF65-F5344CB8AC3E}">
        <p14:creationId xmlns:p14="http://schemas.microsoft.com/office/powerpoint/2010/main" val="24304226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301</TotalTime>
  <Words>78</Words>
  <Application>Microsoft Macintosh PowerPoint</Application>
  <PresentationFormat>On-screen Show (4:3)</PresentationFormat>
  <Paragraphs>11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Arial Narrow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apeng</dc:creator>
  <cp:lastModifiedBy>渡邉　登喜子</cp:lastModifiedBy>
  <cp:revision>301</cp:revision>
  <cp:lastPrinted>2019-06-20T02:39:10Z</cp:lastPrinted>
  <dcterms:created xsi:type="dcterms:W3CDTF">2017-07-06T13:39:56Z</dcterms:created>
  <dcterms:modified xsi:type="dcterms:W3CDTF">2019-09-12T02:22:12Z</dcterms:modified>
</cp:coreProperties>
</file>